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9" r:id="rId2"/>
  </p:sldIdLst>
  <p:sldSz cx="6254750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. Figure 1" id="{A5DB022F-8E33-44DC-A11F-5A2EC3C66E8E}">
          <p14:sldIdLst>
            <p14:sldId id="269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9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skarimi" initials="s" lastIdx="4" clrIdx="1">
    <p:extLst>
      <p:ext uri="{19B8F6BF-5375-455C-9EA6-DF929625EA0E}">
        <p15:presenceInfo xmlns:p15="http://schemas.microsoft.com/office/powerpoint/2012/main" userId="skarimi" providerId="None"/>
      </p:ext>
    </p:extLst>
  </p:cmAuthor>
  <p:cmAuthor id="3" name="soheila karimi" initials="sk" lastIdx="6" clrIdx="2">
    <p:extLst>
      <p:ext uri="{19B8F6BF-5375-455C-9EA6-DF929625EA0E}">
        <p15:presenceInfo xmlns:p15="http://schemas.microsoft.com/office/powerpoint/2012/main" userId="bb0168d6462bdf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D222"/>
    <a:srgbClr val="EAB200"/>
    <a:srgbClr val="EA6B14"/>
    <a:srgbClr val="3333FF"/>
    <a:srgbClr val="00FF00"/>
    <a:srgbClr val="1DFF1D"/>
    <a:srgbClr val="000300"/>
    <a:srgbClr val="66A2D8"/>
    <a:srgbClr val="84B4E0"/>
    <a:srgbClr val="5F5F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26" autoAdjust="0"/>
    <p:restoredTop sz="86861" autoAdjust="0"/>
  </p:normalViewPr>
  <p:slideViewPr>
    <p:cSldViewPr snapToGrid="0">
      <p:cViewPr>
        <p:scale>
          <a:sx n="59" d="100"/>
          <a:sy n="59" d="100"/>
        </p:scale>
        <p:origin x="22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17B45-D4D3-45CB-934D-97DF67DE9D2D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7588" y="1143000"/>
            <a:ext cx="2282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61A00-9F51-4288-915B-64876428B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173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1pPr>
    <a:lvl2pPr marL="36804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2pPr>
    <a:lvl3pPr marL="73609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3pPr>
    <a:lvl4pPr marL="110413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4pPr>
    <a:lvl5pPr marL="1472184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5pPr>
    <a:lvl6pPr marL="184023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6pPr>
    <a:lvl7pPr marL="220827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7pPr>
    <a:lvl8pPr marL="257632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8pPr>
    <a:lvl9pPr marL="294436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106" y="1384248"/>
            <a:ext cx="5316538" cy="2944707"/>
          </a:xfrm>
        </p:spPr>
        <p:txBody>
          <a:bodyPr anchor="b"/>
          <a:lstStyle>
            <a:lvl1pPr algn="ctr"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1844" y="4442514"/>
            <a:ext cx="4691063" cy="2042106"/>
          </a:xfrm>
        </p:spPr>
        <p:txBody>
          <a:bodyPr/>
          <a:lstStyle>
            <a:lvl1pPr marL="0" indent="0" algn="ctr">
              <a:buNone/>
              <a:defRPr sz="1642"/>
            </a:lvl1pPr>
            <a:lvl2pPr marL="312725" indent="0" algn="ctr">
              <a:buNone/>
              <a:defRPr sz="1368"/>
            </a:lvl2pPr>
            <a:lvl3pPr marL="625450" indent="0" algn="ctr">
              <a:buNone/>
              <a:defRPr sz="1231"/>
            </a:lvl3pPr>
            <a:lvl4pPr marL="938174" indent="0" algn="ctr">
              <a:buNone/>
              <a:defRPr sz="1094"/>
            </a:lvl4pPr>
            <a:lvl5pPr marL="1250899" indent="0" algn="ctr">
              <a:buNone/>
              <a:defRPr sz="1094"/>
            </a:lvl5pPr>
            <a:lvl6pPr marL="1563624" indent="0" algn="ctr">
              <a:buNone/>
              <a:defRPr sz="1094"/>
            </a:lvl6pPr>
            <a:lvl7pPr marL="1876349" indent="0" algn="ctr">
              <a:buNone/>
              <a:defRPr sz="1094"/>
            </a:lvl7pPr>
            <a:lvl8pPr marL="2189074" indent="0" algn="ctr">
              <a:buNone/>
              <a:defRPr sz="1094"/>
            </a:lvl8pPr>
            <a:lvl9pPr marL="2501798" indent="0" algn="ctr">
              <a:buNone/>
              <a:defRPr sz="10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567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5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76056" y="450321"/>
            <a:ext cx="1348680" cy="71679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014" y="450321"/>
            <a:ext cx="3967857" cy="716793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46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757" y="2108679"/>
            <a:ext cx="5394722" cy="3518376"/>
          </a:xfrm>
        </p:spPr>
        <p:txBody>
          <a:bodyPr anchor="b"/>
          <a:lstStyle>
            <a:lvl1pPr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757" y="5660339"/>
            <a:ext cx="5394722" cy="1850231"/>
          </a:xfrm>
        </p:spPr>
        <p:txBody>
          <a:bodyPr/>
          <a:lstStyle>
            <a:lvl1pPr marL="0" indent="0">
              <a:buNone/>
              <a:defRPr sz="1642">
                <a:solidFill>
                  <a:schemeClr val="tx1"/>
                </a:solidFill>
              </a:defRPr>
            </a:lvl1pPr>
            <a:lvl2pPr marL="312725" indent="0">
              <a:buNone/>
              <a:defRPr sz="1368">
                <a:solidFill>
                  <a:schemeClr val="tx1">
                    <a:tint val="75000"/>
                  </a:schemeClr>
                </a:solidFill>
              </a:defRPr>
            </a:lvl2pPr>
            <a:lvl3pPr marL="625450" indent="0">
              <a:buNone/>
              <a:defRPr sz="1231">
                <a:solidFill>
                  <a:schemeClr val="tx1">
                    <a:tint val="75000"/>
                  </a:schemeClr>
                </a:solidFill>
              </a:defRPr>
            </a:lvl3pPr>
            <a:lvl4pPr marL="9381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4pPr>
            <a:lvl5pPr marL="125089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5pPr>
            <a:lvl6pPr marL="156362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6pPr>
            <a:lvl7pPr marL="187634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7pPr>
            <a:lvl8pPr marL="21890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8pPr>
            <a:lvl9pPr marL="2501798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33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014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66467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3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450323"/>
            <a:ext cx="5394722" cy="16348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829" y="2073434"/>
            <a:ext cx="2646052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0829" y="3089593"/>
            <a:ext cx="2646052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66468" y="2073434"/>
            <a:ext cx="2659083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66468" y="3089593"/>
            <a:ext cx="2659083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7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0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015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59084" y="1217826"/>
            <a:ext cx="3166467" cy="6010804"/>
          </a:xfrm>
        </p:spPr>
        <p:txBody>
          <a:bodyPr/>
          <a:lstStyle>
            <a:lvl1pPr>
              <a:defRPr sz="2189"/>
            </a:lvl1pPr>
            <a:lvl2pPr>
              <a:defRPr sz="1915"/>
            </a:lvl2pPr>
            <a:lvl3pPr>
              <a:defRPr sz="1642"/>
            </a:lvl3pPr>
            <a:lvl4pPr>
              <a:defRPr sz="1368"/>
            </a:lvl4pPr>
            <a:lvl5pPr>
              <a:defRPr sz="1368"/>
            </a:lvl5pPr>
            <a:lvl6pPr>
              <a:defRPr sz="1368"/>
            </a:lvl6pPr>
            <a:lvl7pPr>
              <a:defRPr sz="1368"/>
            </a:lvl7pPr>
            <a:lvl8pPr>
              <a:defRPr sz="1368"/>
            </a:lvl8pPr>
            <a:lvl9pPr>
              <a:defRPr sz="136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4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59084" y="1217826"/>
            <a:ext cx="3166467" cy="6010804"/>
          </a:xfrm>
        </p:spPr>
        <p:txBody>
          <a:bodyPr anchor="t"/>
          <a:lstStyle>
            <a:lvl1pPr marL="0" indent="0">
              <a:buNone/>
              <a:defRPr sz="2189"/>
            </a:lvl1pPr>
            <a:lvl2pPr marL="312725" indent="0">
              <a:buNone/>
              <a:defRPr sz="1915"/>
            </a:lvl2pPr>
            <a:lvl3pPr marL="625450" indent="0">
              <a:buNone/>
              <a:defRPr sz="1642"/>
            </a:lvl3pPr>
            <a:lvl4pPr marL="938174" indent="0">
              <a:buNone/>
              <a:defRPr sz="1368"/>
            </a:lvl4pPr>
            <a:lvl5pPr marL="1250899" indent="0">
              <a:buNone/>
              <a:defRPr sz="1368"/>
            </a:lvl5pPr>
            <a:lvl6pPr marL="1563624" indent="0">
              <a:buNone/>
              <a:defRPr sz="1368"/>
            </a:lvl6pPr>
            <a:lvl7pPr marL="1876349" indent="0">
              <a:buNone/>
              <a:defRPr sz="1368"/>
            </a:lvl7pPr>
            <a:lvl8pPr marL="2189074" indent="0">
              <a:buNone/>
              <a:defRPr sz="1368"/>
            </a:lvl8pPr>
            <a:lvl9pPr marL="2501798" indent="0">
              <a:buNone/>
              <a:defRPr sz="13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3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014" y="450323"/>
            <a:ext cx="5394722" cy="1634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014" y="2251604"/>
            <a:ext cx="5394722" cy="53666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014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1886" y="7839500"/>
            <a:ext cx="2110978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17417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9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25450" rtl="0" eaLnBrk="1" latinLnBrk="0" hangingPunct="1">
        <a:lnSpc>
          <a:spcPct val="90000"/>
        </a:lnSpc>
        <a:spcBef>
          <a:spcPct val="0"/>
        </a:spcBef>
        <a:buNone/>
        <a:defRPr sz="30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362" indent="-156362" algn="l" defTabSz="625450" rtl="0" eaLnBrk="1" latinLnBrk="0" hangingPunct="1">
        <a:lnSpc>
          <a:spcPct val="90000"/>
        </a:lnSpc>
        <a:spcBef>
          <a:spcPts val="684"/>
        </a:spcBef>
        <a:buFont typeface="Arial" panose="020B0604020202020204" pitchFamily="34" charset="0"/>
        <a:buChar char="•"/>
        <a:defRPr sz="1915" kern="1200">
          <a:solidFill>
            <a:schemeClr val="tx1"/>
          </a:solidFill>
          <a:latin typeface="+mn-lt"/>
          <a:ea typeface="+mn-ea"/>
          <a:cs typeface="+mn-cs"/>
        </a:defRPr>
      </a:lvl1pPr>
      <a:lvl2pPr marL="46908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642" kern="1200">
          <a:solidFill>
            <a:schemeClr val="tx1"/>
          </a:solidFill>
          <a:latin typeface="+mn-lt"/>
          <a:ea typeface="+mn-ea"/>
          <a:cs typeface="+mn-cs"/>
        </a:defRPr>
      </a:lvl2pPr>
      <a:lvl3pPr marL="78181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368" kern="1200">
          <a:solidFill>
            <a:schemeClr val="tx1"/>
          </a:solidFill>
          <a:latin typeface="+mn-lt"/>
          <a:ea typeface="+mn-ea"/>
          <a:cs typeface="+mn-cs"/>
        </a:defRPr>
      </a:lvl3pPr>
      <a:lvl4pPr marL="109453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40726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71998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203271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34543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65816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1pPr>
      <a:lvl2pPr marL="312725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2pPr>
      <a:lvl3pPr marL="62545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3pPr>
      <a:lvl4pPr marL="9381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25089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56362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187634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1890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501798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107"/>
          <p:cNvSpPr txBox="1"/>
          <p:nvPr/>
        </p:nvSpPr>
        <p:spPr>
          <a:xfrm>
            <a:off x="62970" y="56200"/>
            <a:ext cx="2884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Shahriary et al.- Supplementary Figure 1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728956" y="527990"/>
            <a:ext cx="4648564" cy="4246121"/>
            <a:chOff x="728956" y="565842"/>
            <a:chExt cx="4648564" cy="4246121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45945" y="3634327"/>
              <a:ext cx="1509513" cy="1177636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08812" y="3634327"/>
              <a:ext cx="1515505" cy="117763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52974" y="3634327"/>
              <a:ext cx="1515458" cy="1177636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57058" y="2207169"/>
              <a:ext cx="1520462" cy="1147027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08812" y="2207032"/>
              <a:ext cx="1507132" cy="114733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6235" y="2205793"/>
              <a:ext cx="1522197" cy="1145156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90869" y="805285"/>
              <a:ext cx="1510729" cy="1164813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835588" y="804346"/>
              <a:ext cx="1533386" cy="1167789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28956" y="804346"/>
              <a:ext cx="1521901" cy="1164943"/>
            </a:xfrm>
            <a:prstGeom prst="rect">
              <a:avLst/>
            </a:prstGeom>
          </p:spPr>
        </p:pic>
        <p:sp>
          <p:nvSpPr>
            <p:cNvPr id="74" name="Text Box 2"/>
            <p:cNvSpPr txBox="1">
              <a:spLocks noChangeArrowheads="1"/>
            </p:cNvSpPr>
            <p:nvPr/>
          </p:nvSpPr>
          <p:spPr bwMode="auto">
            <a:xfrm>
              <a:off x="746904" y="1978409"/>
              <a:ext cx="1516648" cy="1961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FF0000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rPr>
                <a:t>ErbB2</a:t>
              </a:r>
              <a:endParaRPr lang="en-US" sz="1100" dirty="0">
                <a:solidFill>
                  <a:schemeClr val="accent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75" name="Text Box 2"/>
            <p:cNvSpPr txBox="1">
              <a:spLocks noChangeArrowheads="1"/>
            </p:cNvSpPr>
            <p:nvPr/>
          </p:nvSpPr>
          <p:spPr bwMode="auto">
            <a:xfrm>
              <a:off x="766117" y="572942"/>
              <a:ext cx="1511481" cy="2269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00B050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rPr>
                <a:t>OX42</a:t>
              </a:r>
              <a:endParaRPr lang="en-US" sz="1100" dirty="0">
                <a:solidFill>
                  <a:srgbClr val="00B050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76" name="Text Box 2"/>
            <p:cNvSpPr txBox="1">
              <a:spLocks noChangeArrowheads="1"/>
            </p:cNvSpPr>
            <p:nvPr/>
          </p:nvSpPr>
          <p:spPr bwMode="auto">
            <a:xfrm>
              <a:off x="2313944" y="565842"/>
              <a:ext cx="1512740" cy="232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00B050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rPr>
                <a:t>OX42</a:t>
              </a:r>
              <a:endParaRPr lang="en-US" sz="1100" dirty="0">
                <a:solidFill>
                  <a:srgbClr val="00B050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77" name="Text Box 2"/>
            <p:cNvSpPr txBox="1">
              <a:spLocks noChangeArrowheads="1"/>
            </p:cNvSpPr>
            <p:nvPr/>
          </p:nvSpPr>
          <p:spPr bwMode="auto">
            <a:xfrm>
              <a:off x="3820023" y="572411"/>
              <a:ext cx="1500010" cy="2325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00B050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rPr>
                <a:t>OX42</a:t>
              </a:r>
              <a:endParaRPr lang="en-US" sz="1100" dirty="0">
                <a:solidFill>
                  <a:srgbClr val="00B050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78" name="Text Box 2"/>
            <p:cNvSpPr txBox="1">
              <a:spLocks noChangeArrowheads="1"/>
            </p:cNvSpPr>
            <p:nvPr/>
          </p:nvSpPr>
          <p:spPr bwMode="auto">
            <a:xfrm>
              <a:off x="2306489" y="1964202"/>
              <a:ext cx="1512740" cy="2310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FF0000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rPr>
                <a:t>ErbB3</a:t>
              </a:r>
              <a:endParaRPr lang="en-US" sz="1100" dirty="0">
                <a:solidFill>
                  <a:schemeClr val="accent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79" name="Text Box 2"/>
            <p:cNvSpPr txBox="1">
              <a:spLocks noChangeArrowheads="1"/>
            </p:cNvSpPr>
            <p:nvPr/>
          </p:nvSpPr>
          <p:spPr bwMode="auto">
            <a:xfrm>
              <a:off x="3856167" y="1982068"/>
              <a:ext cx="1502552" cy="2310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FF0000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rPr>
                <a:t>ErbB4</a:t>
              </a:r>
              <a:endParaRPr lang="en-US" sz="1100" dirty="0">
                <a:solidFill>
                  <a:schemeClr val="accent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749813" y="787902"/>
              <a:ext cx="263214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</a:p>
          </p:txBody>
        </p:sp>
        <p:sp>
          <p:nvSpPr>
            <p:cNvPr id="85" name="Text Box 2"/>
            <p:cNvSpPr txBox="1">
              <a:spLocks noChangeArrowheads="1"/>
            </p:cNvSpPr>
            <p:nvPr/>
          </p:nvSpPr>
          <p:spPr bwMode="auto">
            <a:xfrm>
              <a:off x="746904" y="3389098"/>
              <a:ext cx="1511481" cy="233478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00B05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OX42</a:t>
              </a:r>
              <a:r>
                <a:rPr lang="en-US" sz="1100" b="1" dirty="0"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/</a:t>
              </a:r>
              <a:r>
                <a:rPr lang="en-US" sz="1100" b="1" dirty="0">
                  <a:solidFill>
                    <a:srgbClr val="FF000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ErbB2</a:t>
              </a:r>
              <a:r>
                <a:rPr lang="en-US" sz="1100" b="1" dirty="0"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/</a:t>
              </a:r>
              <a:r>
                <a:rPr lang="en-US" sz="1100" b="1" dirty="0">
                  <a:solidFill>
                    <a:srgbClr val="0070C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DAPI</a:t>
              </a:r>
              <a:r>
                <a:rPr lang="en-US" sz="1100" b="1" dirty="0">
                  <a:solidFill>
                    <a:schemeClr val="accent1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                     </a:t>
              </a:r>
              <a:endParaRPr lang="en-US" sz="1100" dirty="0">
                <a:solidFill>
                  <a:schemeClr val="accent1"/>
                </a:solidFill>
                <a:latin typeface="Helvetica" panose="020B0604020202020204" pitchFamily="34" charset="0"/>
                <a:ea typeface="SimHei" pitchFamily="49" charset="-122"/>
                <a:cs typeface="Helvetica" panose="020B0604020202020204" pitchFamily="34" charset="0"/>
              </a:endParaRPr>
            </a:p>
          </p:txBody>
        </p:sp>
        <p:sp>
          <p:nvSpPr>
            <p:cNvPr id="86" name="Text Box 2"/>
            <p:cNvSpPr txBox="1">
              <a:spLocks noChangeArrowheads="1"/>
            </p:cNvSpPr>
            <p:nvPr/>
          </p:nvSpPr>
          <p:spPr bwMode="auto">
            <a:xfrm>
              <a:off x="2300229" y="3389897"/>
              <a:ext cx="1514093" cy="232679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00B05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OX42</a:t>
              </a:r>
              <a:r>
                <a:rPr lang="en-US" sz="1100" b="1" dirty="0"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/</a:t>
              </a:r>
              <a:r>
                <a:rPr lang="en-US" sz="1100" b="1" dirty="0">
                  <a:solidFill>
                    <a:srgbClr val="FF000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ErbB3</a:t>
              </a:r>
              <a:r>
                <a:rPr lang="en-US" sz="1100" b="1" dirty="0"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/</a:t>
              </a:r>
              <a:r>
                <a:rPr lang="en-US" sz="1100" b="1" dirty="0">
                  <a:solidFill>
                    <a:srgbClr val="0070C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DAPI</a:t>
              </a:r>
              <a:r>
                <a:rPr lang="en-US" sz="1100" b="1" dirty="0">
                  <a:solidFill>
                    <a:schemeClr val="accent1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                     </a:t>
              </a:r>
              <a:endParaRPr lang="en-US" sz="1100" dirty="0">
                <a:solidFill>
                  <a:schemeClr val="accent1"/>
                </a:solidFill>
                <a:latin typeface="Helvetica" panose="020B0604020202020204" pitchFamily="34" charset="0"/>
                <a:ea typeface="SimHei" pitchFamily="49" charset="-122"/>
                <a:cs typeface="Helvetica" panose="020B0604020202020204" pitchFamily="34" charset="0"/>
              </a:endParaRPr>
            </a:p>
          </p:txBody>
        </p:sp>
        <p:sp>
          <p:nvSpPr>
            <p:cNvPr id="87" name="Text Box 2"/>
            <p:cNvSpPr txBox="1">
              <a:spLocks noChangeArrowheads="1"/>
            </p:cNvSpPr>
            <p:nvPr/>
          </p:nvSpPr>
          <p:spPr bwMode="auto">
            <a:xfrm>
              <a:off x="3856168" y="3377668"/>
              <a:ext cx="1502551" cy="2371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68385" tIns="34193" rIns="68385" bIns="34193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748"/>
                </a:spcAft>
              </a:pPr>
              <a:r>
                <a:rPr lang="en-US" sz="1100" b="1" dirty="0">
                  <a:solidFill>
                    <a:srgbClr val="00B05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OX42</a:t>
              </a:r>
              <a:r>
                <a:rPr lang="en-US" sz="1100" b="1" dirty="0"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/</a:t>
              </a:r>
              <a:r>
                <a:rPr lang="en-US" sz="1100" b="1" dirty="0">
                  <a:solidFill>
                    <a:srgbClr val="FF000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ErbB4</a:t>
              </a:r>
              <a:r>
                <a:rPr lang="en-US" sz="1100" b="1" dirty="0"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/</a:t>
              </a:r>
              <a:r>
                <a:rPr lang="en-US" sz="1100" b="1" dirty="0">
                  <a:solidFill>
                    <a:srgbClr val="0070C0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DAPI</a:t>
              </a:r>
              <a:r>
                <a:rPr lang="en-US" sz="1100" b="1" dirty="0">
                  <a:solidFill>
                    <a:schemeClr val="accent1"/>
                  </a:solidFill>
                  <a:latin typeface="Helvetica" panose="020B0604020202020204" pitchFamily="34" charset="0"/>
                  <a:ea typeface="SimHei" pitchFamily="49" charset="-122"/>
                  <a:cs typeface="Helvetica" panose="020B0604020202020204" pitchFamily="34" charset="0"/>
                </a:rPr>
                <a:t>                     </a:t>
              </a:r>
              <a:endParaRPr lang="en-US" sz="1100" dirty="0">
                <a:solidFill>
                  <a:schemeClr val="accent1"/>
                </a:solidFill>
                <a:latin typeface="Helvetica" panose="020B0604020202020204" pitchFamily="34" charset="0"/>
                <a:ea typeface="SimHei" pitchFamily="49" charset="-122"/>
                <a:cs typeface="Helvetica" panose="020B0604020202020204" pitchFamily="34" charset="0"/>
              </a:endParaRPr>
            </a:p>
          </p:txBody>
        </p:sp>
        <p:grpSp>
          <p:nvGrpSpPr>
            <p:cNvPr id="89" name="Group 88"/>
            <p:cNvGrpSpPr/>
            <p:nvPr/>
          </p:nvGrpSpPr>
          <p:grpSpPr>
            <a:xfrm>
              <a:off x="4364582" y="4460097"/>
              <a:ext cx="920793" cy="263576"/>
              <a:chOff x="5355697" y="6006286"/>
              <a:chExt cx="1251687" cy="351946"/>
            </a:xfrm>
          </p:grpSpPr>
          <p:sp>
            <p:nvSpPr>
              <p:cNvPr id="91" name="TextBox 90"/>
              <p:cNvSpPr txBox="1"/>
              <p:nvPr/>
            </p:nvSpPr>
            <p:spPr>
              <a:xfrm>
                <a:off x="5813482" y="6006286"/>
                <a:ext cx="745672" cy="3493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25µm</a:t>
                </a:r>
              </a:p>
            </p:txBody>
          </p:sp>
          <p:cxnSp>
            <p:nvCxnSpPr>
              <p:cNvPr id="92" name="Straight Connector 91"/>
              <p:cNvCxnSpPr/>
              <p:nvPr/>
            </p:nvCxnSpPr>
            <p:spPr>
              <a:xfrm>
                <a:off x="5355697" y="6349546"/>
                <a:ext cx="1251687" cy="8686"/>
              </a:xfrm>
              <a:prstGeom prst="line">
                <a:avLst/>
              </a:prstGeom>
              <a:ln w="28575">
                <a:noFill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3" name="Straight Connector 92"/>
            <p:cNvCxnSpPr/>
            <p:nvPr/>
          </p:nvCxnSpPr>
          <p:spPr>
            <a:xfrm flipV="1">
              <a:off x="4660597" y="4729027"/>
              <a:ext cx="608535" cy="496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/>
            <p:cNvSpPr txBox="1"/>
            <p:nvPr/>
          </p:nvSpPr>
          <p:spPr>
            <a:xfrm>
              <a:off x="744481" y="2209375"/>
              <a:ext cx="27122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752974" y="3642565"/>
              <a:ext cx="27122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c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313492" y="2189383"/>
              <a:ext cx="27122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307486" y="3638615"/>
              <a:ext cx="231154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f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867609" y="2205425"/>
              <a:ext cx="27122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h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860060" y="3638615"/>
              <a:ext cx="22313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i</a:t>
              </a:r>
              <a:endParaRPr lang="en-US" sz="11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291037" y="796755"/>
              <a:ext cx="27122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851151" y="792482"/>
              <a:ext cx="271228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3142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0</TotalTime>
  <Words>26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Hei</vt:lpstr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041</cp:revision>
  <cp:lastPrinted>2019-02-02T05:56:56Z</cp:lastPrinted>
  <dcterms:created xsi:type="dcterms:W3CDTF">2018-08-01T14:08:28Z</dcterms:created>
  <dcterms:modified xsi:type="dcterms:W3CDTF">2019-02-14T04:27:35Z</dcterms:modified>
</cp:coreProperties>
</file>